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sldIdLst>
    <p:sldId id="257" r:id="rId3"/>
  </p:sldIdLst>
  <p:sldSz cx="12192000" cy="6858000"/>
  <p:notesSz cx="6858000" cy="9144000"/>
  <p:custDataLst>
    <p:custData r:id="rId1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er Ashorn (TAU)" initials="PA(" lastIdx="1" clrIdx="0">
    <p:extLst>
      <p:ext uri="{19B8F6BF-5375-455C-9EA6-DF929625EA0E}">
        <p15:presenceInfo xmlns:p15="http://schemas.microsoft.com/office/powerpoint/2012/main" userId="S::per.ashorn@tuni.fi::2dd6b6ad-fe7d-4eab-96b9-4ecd7717a1b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295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460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628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384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126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375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102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7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680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03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66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742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34"/>
          <p:cNvSpPr txBox="1">
            <a:spLocks noChangeArrowheads="1"/>
          </p:cNvSpPr>
          <p:nvPr/>
        </p:nvSpPr>
        <p:spPr bwMode="auto">
          <a:xfrm>
            <a:off x="2304509" y="3443139"/>
            <a:ext cx="1156936" cy="42629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FA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01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33"/>
          <p:cNvSpPr txBox="1">
            <a:spLocks noChangeArrowheads="1"/>
          </p:cNvSpPr>
          <p:nvPr/>
        </p:nvSpPr>
        <p:spPr bwMode="auto">
          <a:xfrm>
            <a:off x="8859185" y="3438395"/>
            <a:ext cx="1277960" cy="43197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01 L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S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01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35"/>
          <p:cNvSpPr txBox="1">
            <a:spLocks noChangeArrowheads="1"/>
          </p:cNvSpPr>
          <p:nvPr/>
        </p:nvSpPr>
        <p:spPr bwMode="auto">
          <a:xfrm>
            <a:off x="5665218" y="3400625"/>
            <a:ext cx="1188878" cy="42629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MN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01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26"/>
          <p:cNvSpPr txBox="1">
            <a:spLocks noChangeArrowheads="1"/>
          </p:cNvSpPr>
          <p:nvPr/>
        </p:nvSpPr>
        <p:spPr bwMode="auto">
          <a:xfrm>
            <a:off x="2101716" y="4341919"/>
            <a:ext cx="1726356" cy="59164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ild 6 </a:t>
            </a:r>
            <a:r>
              <a:rPr kumimoji="0" lang="en-US" altLang="en-US" sz="1200" b="0" i="0" u="sng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o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ge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0" lang="en-US" alt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asma 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tinol</a:t>
            </a:r>
            <a:r>
              <a:rPr kumimoji="0" lang="en-US" altLang="en-US" sz="12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: n=97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0" lang="en-US" altLang="en-US" sz="1000" b="0" i="0" u="none" strike="noStrike" cap="none" normalizeH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aseline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6"/>
          <p:cNvSpPr txBox="1">
            <a:spLocks noChangeArrowheads="1"/>
          </p:cNvSpPr>
          <p:nvPr/>
        </p:nvSpPr>
        <p:spPr bwMode="auto">
          <a:xfrm>
            <a:off x="4992006" y="893290"/>
            <a:ext cx="2469325" cy="352954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320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mother-chil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 pair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nrolled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 Box 26"/>
          <p:cNvSpPr txBox="1">
            <a:spLocks noChangeArrowheads="1"/>
          </p:cNvSpPr>
          <p:nvPr/>
        </p:nvSpPr>
        <p:spPr bwMode="auto">
          <a:xfrm>
            <a:off x="8578334" y="4338724"/>
            <a:ext cx="1770929" cy="587384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ild 6 </a:t>
            </a:r>
            <a:r>
              <a:rPr lang="en-US" altLang="en-US" sz="1200" u="sng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o</a:t>
            </a: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ge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tinol: n=96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 Box 26"/>
          <p:cNvSpPr txBox="1">
            <a:spLocks noChangeArrowheads="1"/>
          </p:cNvSpPr>
          <p:nvPr/>
        </p:nvSpPr>
        <p:spPr bwMode="auto">
          <a:xfrm>
            <a:off x="5350739" y="4341919"/>
            <a:ext cx="1751864" cy="594874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ild 6 </a:t>
            </a:r>
            <a:r>
              <a:rPr lang="en-US" altLang="en-US" sz="1200" u="sng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o</a:t>
            </a: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ge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a 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tinol: </a:t>
            </a:r>
            <a:r>
              <a:rPr lang="en-US" alt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99</a:t>
            </a:r>
            <a:endParaRPr lang="en-US" alt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 Box 26"/>
          <p:cNvSpPr txBox="1">
            <a:spLocks noChangeArrowheads="1"/>
          </p:cNvSpPr>
          <p:nvPr/>
        </p:nvSpPr>
        <p:spPr bwMode="auto">
          <a:xfrm>
            <a:off x="2101716" y="5329832"/>
            <a:ext cx="1726356" cy="57893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ild 18 </a:t>
            </a:r>
            <a:r>
              <a:rPr lang="en-US" altLang="en-US" sz="1200" u="sng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o</a:t>
            </a: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ge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lasma 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tinol: n=97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41" name="Text Box 26"/>
          <p:cNvSpPr txBox="1">
            <a:spLocks noChangeArrowheads="1"/>
          </p:cNvSpPr>
          <p:nvPr/>
        </p:nvSpPr>
        <p:spPr bwMode="auto">
          <a:xfrm>
            <a:off x="8578332" y="5329832"/>
            <a:ext cx="1770931" cy="57893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ild 18 </a:t>
            </a:r>
            <a:r>
              <a:rPr lang="en-US" altLang="en-US" sz="1200" u="sng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o</a:t>
            </a: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ge</a:t>
            </a:r>
            <a:r>
              <a:rPr kumimoji="0" lang="en-US" altLang="en-US" sz="1200" b="0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lasma 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tinol: </a:t>
            </a:r>
            <a:r>
              <a:rPr lang="en-US" altLang="en-US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=96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endParaRPr lang="en-US" altLang="en-US" sz="1000" dirty="0" smtClean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-"/>
              <a:tabLst/>
            </a:pP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42" name="Text Box 26"/>
          <p:cNvSpPr txBox="1">
            <a:spLocks noChangeArrowheads="1"/>
          </p:cNvSpPr>
          <p:nvPr/>
        </p:nvSpPr>
        <p:spPr bwMode="auto">
          <a:xfrm>
            <a:off x="5355616" y="5323542"/>
            <a:ext cx="1746987" cy="58522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ild 18 </a:t>
            </a:r>
            <a:r>
              <a:rPr lang="en-US" altLang="en-US" sz="1200" u="sng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o</a:t>
            </a:r>
            <a:r>
              <a:rPr lang="en-US" altLang="en-US" sz="1200" u="sng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age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asma </a:t>
            </a: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tinol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n=99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cxnSp>
        <p:nvCxnSpPr>
          <p:cNvPr id="60" name="Straight Arrow Connector 59"/>
          <p:cNvCxnSpPr/>
          <p:nvPr/>
        </p:nvCxnSpPr>
        <p:spPr>
          <a:xfrm>
            <a:off x="6204613" y="1289304"/>
            <a:ext cx="0" cy="18001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/>
        </p:nvSpPr>
        <p:spPr>
          <a:xfrm>
            <a:off x="2450407" y="1401193"/>
            <a:ext cx="1953030" cy="461664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10 mother-child pairs not</a:t>
            </a:r>
          </a:p>
          <a:p>
            <a:pPr algn="ctr"/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ligible for subsample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cxnSp>
        <p:nvCxnSpPr>
          <p:cNvPr id="101" name="Straight Arrow Connector 100"/>
          <p:cNvCxnSpPr/>
          <p:nvPr/>
        </p:nvCxnSpPr>
        <p:spPr>
          <a:xfrm>
            <a:off x="6229108" y="3976571"/>
            <a:ext cx="1" cy="2902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/>
          <p:nvPr/>
        </p:nvCxnSpPr>
        <p:spPr>
          <a:xfrm>
            <a:off x="2920610" y="3951212"/>
            <a:ext cx="1" cy="2902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/>
          <p:cNvCxnSpPr/>
          <p:nvPr/>
        </p:nvCxnSpPr>
        <p:spPr>
          <a:xfrm>
            <a:off x="9498165" y="3976570"/>
            <a:ext cx="1" cy="2902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/>
          <p:nvPr/>
        </p:nvCxnSpPr>
        <p:spPr>
          <a:xfrm>
            <a:off x="9514797" y="4997983"/>
            <a:ext cx="1" cy="2902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6204613" y="4978758"/>
            <a:ext cx="1" cy="2902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>
            <a:off x="2882976" y="4961105"/>
            <a:ext cx="1" cy="29027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35"/>
          <p:cNvSpPr txBox="1">
            <a:spLocks noChangeArrowheads="1"/>
          </p:cNvSpPr>
          <p:nvPr/>
        </p:nvSpPr>
        <p:spPr bwMode="auto">
          <a:xfrm>
            <a:off x="5322913" y="1485933"/>
            <a:ext cx="1967841" cy="29991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810 eligible for subsample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35"/>
          <p:cNvSpPr txBox="1">
            <a:spLocks noChangeArrowheads="1"/>
          </p:cNvSpPr>
          <p:nvPr/>
        </p:nvSpPr>
        <p:spPr bwMode="auto">
          <a:xfrm>
            <a:off x="5192510" y="2115199"/>
            <a:ext cx="2134292" cy="57869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03 children selected for subsample for plasma retinol analysis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 flipH="1">
            <a:off x="6226669" y="1823975"/>
            <a:ext cx="2" cy="27292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2935553" y="3055645"/>
            <a:ext cx="6579244" cy="20131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2935553" y="3055645"/>
            <a:ext cx="0" cy="22463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6228862" y="3107566"/>
            <a:ext cx="0" cy="216809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H="1">
            <a:off x="6228862" y="2739801"/>
            <a:ext cx="2" cy="27292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6"/>
          <p:cNvSpPr txBox="1">
            <a:spLocks noChangeArrowheads="1"/>
          </p:cNvSpPr>
          <p:nvPr/>
        </p:nvSpPr>
        <p:spPr bwMode="auto">
          <a:xfrm>
            <a:off x="2387745" y="1393053"/>
            <a:ext cx="1953031" cy="53398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9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Straight Arrow Connector 48"/>
          <p:cNvCxnSpPr/>
          <p:nvPr/>
        </p:nvCxnSpPr>
        <p:spPr>
          <a:xfrm flipH="1">
            <a:off x="4553781" y="1606047"/>
            <a:ext cx="583669" cy="194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9514797" y="3080450"/>
            <a:ext cx="0" cy="216809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2304509" y="6196501"/>
            <a:ext cx="80826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2. Enrollment and selection of Ghanaian children for plasma retinol analyses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6368" y="208405"/>
            <a:ext cx="10926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mall-quantity lipid-based nutrient supplements do not affect plasma or milk retinol concentrations among Malawian mothers, or plasma retinol concentrations 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o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oung Malawian or Ghanaian children in two randomiz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ials, Marjorie Haskell, Online Supplementary Mater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2927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IAPPresMetadata>
  <IAPAddInVersion>5.1.2</IAPAddInVersion>
  <DolphinEchoVersion>6.1.3</DolphinEchoVersion>
</IAPPresMetadata>
</file>

<file path=customXml/itemProps1.xml><?xml version="1.0" encoding="utf-8"?>
<ds:datastoreItem xmlns:ds="http://schemas.openxmlformats.org/officeDocument/2006/customXml" ds:itemID="{07BEFC14-307E-4419-B786-43EAA42716D2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Words>146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orie Haskell</dc:creator>
  <cp:lastModifiedBy>Marjorie Haskell</cp:lastModifiedBy>
  <cp:revision>34</cp:revision>
  <dcterms:modified xsi:type="dcterms:W3CDTF">2020-12-08T20:39:40Z</dcterms:modified>
</cp:coreProperties>
</file>